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64" r:id="rId2"/>
    <p:sldId id="256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83145A9-03B8-434B-88F1-EE71084D8059}" v="5" dt="2025-05-19T14:00:35.05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69" autoAdjust="0"/>
    <p:restoredTop sz="94660"/>
  </p:normalViewPr>
  <p:slideViewPr>
    <p:cSldViewPr snapToGrid="0">
      <p:cViewPr>
        <p:scale>
          <a:sx n="130" d="100"/>
          <a:sy n="130" d="100"/>
        </p:scale>
        <p:origin x="190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iulia LONGHI" userId="7dc784af-0b5a-4173-9888-8011828b356b" providerId="ADAL" clId="{C83145A9-03B8-434B-88F1-EE71084D8059}"/>
    <pc:docChg chg="undo custSel addSld delSld modSld">
      <pc:chgData name="Giulia LONGHI" userId="7dc784af-0b5a-4173-9888-8011828b356b" providerId="ADAL" clId="{C83145A9-03B8-434B-88F1-EE71084D8059}" dt="2025-05-19T14:00:48.191" v="189" actId="1036"/>
      <pc:docMkLst>
        <pc:docMk/>
      </pc:docMkLst>
      <pc:sldChg chg="addSp delSp modSp add mod">
        <pc:chgData name="Giulia LONGHI" userId="7dc784af-0b5a-4173-9888-8011828b356b" providerId="ADAL" clId="{C83145A9-03B8-434B-88F1-EE71084D8059}" dt="2025-05-19T14:00:48.191" v="189" actId="1036"/>
        <pc:sldMkLst>
          <pc:docMk/>
          <pc:sldMk cId="1851375140" sldId="256"/>
        </pc:sldMkLst>
        <pc:spChg chg="add mod">
          <ac:chgData name="Giulia LONGHI" userId="7dc784af-0b5a-4173-9888-8011828b356b" providerId="ADAL" clId="{C83145A9-03B8-434B-88F1-EE71084D8059}" dt="2025-05-16T13:04:10.287" v="5" actId="20577"/>
          <ac:spMkLst>
            <pc:docMk/>
            <pc:sldMk cId="1851375140" sldId="256"/>
            <ac:spMk id="2" creationId="{D69191FB-C277-D035-1FF8-6E4DCE9892DD}"/>
          </ac:spMkLst>
        </pc:spChg>
        <pc:spChg chg="add mod">
          <ac:chgData name="Giulia LONGHI" userId="7dc784af-0b5a-4173-9888-8011828b356b" providerId="ADAL" clId="{C83145A9-03B8-434B-88F1-EE71084D8059}" dt="2025-05-16T13:41:48.765" v="18" actId="1076"/>
          <ac:spMkLst>
            <pc:docMk/>
            <pc:sldMk cId="1851375140" sldId="256"/>
            <ac:spMk id="3" creationId="{EC704699-675A-FC18-7DF9-B3194BF0086A}"/>
          </ac:spMkLst>
        </pc:spChg>
        <pc:spChg chg="add del mod">
          <ac:chgData name="Giulia LONGHI" userId="7dc784af-0b5a-4173-9888-8011828b356b" providerId="ADAL" clId="{C83145A9-03B8-434B-88F1-EE71084D8059}" dt="2025-05-19T13:57:59.241" v="183" actId="478"/>
          <ac:spMkLst>
            <pc:docMk/>
            <pc:sldMk cId="1851375140" sldId="256"/>
            <ac:spMk id="4" creationId="{D2FDBF22-6923-222B-991F-F3EF05BB2C4D}"/>
          </ac:spMkLst>
        </pc:spChg>
        <pc:spChg chg="add mod">
          <ac:chgData name="Giulia LONGHI" userId="7dc784af-0b5a-4173-9888-8011828b356b" providerId="ADAL" clId="{C83145A9-03B8-434B-88F1-EE71084D8059}" dt="2025-05-19T14:00:48.191" v="189" actId="1036"/>
          <ac:spMkLst>
            <pc:docMk/>
            <pc:sldMk cId="1851375140" sldId="256"/>
            <ac:spMk id="6" creationId="{251F0E64-8A1D-CD89-9E39-71974D9BD119}"/>
          </ac:spMkLst>
        </pc:spChg>
        <pc:picChg chg="mod">
          <ac:chgData name="Giulia LONGHI" userId="7dc784af-0b5a-4173-9888-8011828b356b" providerId="ADAL" clId="{C83145A9-03B8-434B-88F1-EE71084D8059}" dt="2025-05-19T13:57:50.935" v="182" actId="1036"/>
          <ac:picMkLst>
            <pc:docMk/>
            <pc:sldMk cId="1851375140" sldId="256"/>
            <ac:picMk id="5" creationId="{31170B6B-DEE4-512E-E622-5B606D392200}"/>
          </ac:picMkLst>
        </pc:picChg>
        <pc:picChg chg="mod">
          <ac:chgData name="Giulia LONGHI" userId="7dc784af-0b5a-4173-9888-8011828b356b" providerId="ADAL" clId="{C83145A9-03B8-434B-88F1-EE71084D8059}" dt="2025-05-19T13:57:50.935" v="182" actId="1036"/>
          <ac:picMkLst>
            <pc:docMk/>
            <pc:sldMk cId="1851375140" sldId="256"/>
            <ac:picMk id="7" creationId="{99B647C9-BBC1-ADEA-088F-C6801248134B}"/>
          </ac:picMkLst>
        </pc:picChg>
        <pc:picChg chg="mod">
          <ac:chgData name="Giulia LONGHI" userId="7dc784af-0b5a-4173-9888-8011828b356b" providerId="ADAL" clId="{C83145A9-03B8-434B-88F1-EE71084D8059}" dt="2025-05-19T13:57:50.935" v="182" actId="1036"/>
          <ac:picMkLst>
            <pc:docMk/>
            <pc:sldMk cId="1851375140" sldId="256"/>
            <ac:picMk id="9" creationId="{FBA98618-853F-C1A4-BB56-E8A34E33D202}"/>
          </ac:picMkLst>
        </pc:picChg>
        <pc:picChg chg="mod modCrop">
          <ac:chgData name="Giulia LONGHI" userId="7dc784af-0b5a-4173-9888-8011828b356b" providerId="ADAL" clId="{C83145A9-03B8-434B-88F1-EE71084D8059}" dt="2025-05-19T13:57:42.919" v="145" actId="1038"/>
          <ac:picMkLst>
            <pc:docMk/>
            <pc:sldMk cId="1851375140" sldId="256"/>
            <ac:picMk id="11" creationId="{7F83B681-8F79-2280-015E-76B339E69BD3}"/>
          </ac:picMkLst>
        </pc:picChg>
      </pc:sldChg>
      <pc:sldChg chg="new del">
        <pc:chgData name="Giulia LONGHI" userId="7dc784af-0b5a-4173-9888-8011828b356b" providerId="ADAL" clId="{C83145A9-03B8-434B-88F1-EE71084D8059}" dt="2025-05-16T13:01:47.604" v="1" actId="47"/>
        <pc:sldMkLst>
          <pc:docMk/>
          <pc:sldMk cId="3197301348" sldId="265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AE6404-2904-4AA4-89C3-E3F04362B5B8}" type="datetimeFigureOut">
              <a:rPr lang="en-US" smtClean="0"/>
              <a:t>5/19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B80D54-EF39-4FD6-973D-170C088FFC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5875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DB80D54-EF39-4FD6-973D-170C088FFCD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87088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3EB8E-F358-4FB2-A276-B13907E67FA9}" type="datetimeFigureOut">
              <a:rPr lang="en-US" smtClean="0"/>
              <a:t>5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24492-0D65-48F1-A3C9-8E859C0BB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9950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3EB8E-F358-4FB2-A276-B13907E67FA9}" type="datetimeFigureOut">
              <a:rPr lang="en-US" smtClean="0"/>
              <a:t>5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24492-0D65-48F1-A3C9-8E859C0BB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26020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3EB8E-F358-4FB2-A276-B13907E67FA9}" type="datetimeFigureOut">
              <a:rPr lang="en-US" smtClean="0"/>
              <a:t>5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24492-0D65-48F1-A3C9-8E859C0BB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9133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3EB8E-F358-4FB2-A276-B13907E67FA9}" type="datetimeFigureOut">
              <a:rPr lang="en-US" smtClean="0"/>
              <a:t>5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24492-0D65-48F1-A3C9-8E859C0BB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46602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3EB8E-F358-4FB2-A276-B13907E67FA9}" type="datetimeFigureOut">
              <a:rPr lang="en-US" smtClean="0"/>
              <a:t>5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24492-0D65-48F1-A3C9-8E859C0BB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56534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3EB8E-F358-4FB2-A276-B13907E67FA9}" type="datetimeFigureOut">
              <a:rPr lang="en-US" smtClean="0"/>
              <a:t>5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24492-0D65-48F1-A3C9-8E859C0BB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04163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3EB8E-F358-4FB2-A276-B13907E67FA9}" type="datetimeFigureOut">
              <a:rPr lang="en-US" smtClean="0"/>
              <a:t>5/1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24492-0D65-48F1-A3C9-8E859C0BB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5120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3EB8E-F358-4FB2-A276-B13907E67FA9}" type="datetimeFigureOut">
              <a:rPr lang="en-US" smtClean="0"/>
              <a:t>5/1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24492-0D65-48F1-A3C9-8E859C0BB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6646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3EB8E-F358-4FB2-A276-B13907E67FA9}" type="datetimeFigureOut">
              <a:rPr lang="en-US" smtClean="0"/>
              <a:t>5/1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24492-0D65-48F1-A3C9-8E859C0BB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15078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3EB8E-F358-4FB2-A276-B13907E67FA9}" type="datetimeFigureOut">
              <a:rPr lang="en-US" smtClean="0"/>
              <a:t>5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24492-0D65-48F1-A3C9-8E859C0BB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70272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3EB8E-F358-4FB2-A276-B13907E67FA9}" type="datetimeFigureOut">
              <a:rPr lang="en-US" smtClean="0"/>
              <a:t>5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24492-0D65-48F1-A3C9-8E859C0BB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65994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C93EB8E-F358-4FB2-A276-B13907E67FA9}" type="datetimeFigureOut">
              <a:rPr lang="en-US" smtClean="0"/>
              <a:t>5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3024492-0D65-48F1-A3C9-8E859C0BB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90767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PNG"/><Relationship Id="rId4" Type="http://schemas.openxmlformats.org/officeDocument/2006/relationships/image" Target="../media/image5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41D3202-3AA9-ECBE-53EE-E9F62A775EF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Picture 65">
            <a:extLst>
              <a:ext uri="{FF2B5EF4-FFF2-40B4-BE49-F238E27FC236}">
                <a16:creationId xmlns:a16="http://schemas.microsoft.com/office/drawing/2014/main" id="{A75D3ADD-46CF-41F1-239C-5863B851419D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b="26691"/>
          <a:stretch/>
        </p:blipFill>
        <p:spPr>
          <a:xfrm>
            <a:off x="1287248" y="54896"/>
            <a:ext cx="4352491" cy="4101801"/>
          </a:xfrm>
          <a:prstGeom prst="rect">
            <a:avLst/>
          </a:prstGeom>
        </p:spPr>
      </p:pic>
      <p:pic>
        <p:nvPicPr>
          <p:cNvPr id="67" name="Picture 66">
            <a:extLst>
              <a:ext uri="{FF2B5EF4-FFF2-40B4-BE49-F238E27FC236}">
                <a16:creationId xmlns:a16="http://schemas.microsoft.com/office/drawing/2014/main" id="{CAB0E69A-2870-6135-7AA5-841F46196719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t="23522"/>
          <a:stretch/>
        </p:blipFill>
        <p:spPr>
          <a:xfrm>
            <a:off x="1181653" y="4122216"/>
            <a:ext cx="4352491" cy="4095554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5ED853E9-0E26-33FE-6E3F-259985A8E343}"/>
              </a:ext>
            </a:extLst>
          </p:cNvPr>
          <p:cNvGrpSpPr/>
          <p:nvPr/>
        </p:nvGrpSpPr>
        <p:grpSpPr>
          <a:xfrm>
            <a:off x="827646" y="8524835"/>
            <a:ext cx="2670744" cy="1292662"/>
            <a:chOff x="227333" y="10000779"/>
            <a:chExt cx="3287069" cy="1590968"/>
          </a:xfrm>
        </p:grpSpPr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559C321D-03C9-E56C-6EC0-D09485830519}"/>
                </a:ext>
              </a:extLst>
            </p:cNvPr>
            <p:cNvSpPr txBox="1"/>
            <p:nvPr/>
          </p:nvSpPr>
          <p:spPr>
            <a:xfrm>
              <a:off x="227333" y="10000779"/>
              <a:ext cx="3287069" cy="15909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GB" sz="975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GB" sz="975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Bifidobacterium</a:t>
              </a:r>
            </a:p>
            <a:p>
              <a:r>
                <a:rPr lang="en-GB" sz="975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</a:t>
              </a:r>
              <a:r>
                <a:rPr lang="en-GB" sz="975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ombiscardovia</a:t>
              </a:r>
              <a:endParaRPr lang="en-GB" sz="975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GB" sz="975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</a:t>
              </a:r>
              <a:r>
                <a:rPr lang="en-GB" sz="975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lloscardovia</a:t>
              </a:r>
              <a:br>
                <a:rPr lang="en-GB" sz="975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en-GB" sz="975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</a:t>
              </a:r>
              <a:r>
                <a:rPr lang="en-GB" sz="975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arascardovia</a:t>
              </a:r>
              <a:endParaRPr lang="en-GB" sz="975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GB" sz="975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</a:t>
              </a:r>
              <a:r>
                <a:rPr lang="en-GB" sz="975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cardovia</a:t>
              </a:r>
              <a:endParaRPr lang="en-GB" sz="975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GB" sz="975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</a:t>
              </a:r>
              <a:r>
                <a:rPr lang="en-GB" sz="975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eriscardovia</a:t>
              </a:r>
              <a:endParaRPr lang="en-GB" sz="975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GB" sz="975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</a:t>
              </a:r>
              <a:r>
                <a:rPr lang="en-GB" sz="975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seudoscardovia</a:t>
              </a:r>
              <a:endParaRPr lang="en-GB" sz="975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69" name="Group 68">
              <a:extLst>
                <a:ext uri="{FF2B5EF4-FFF2-40B4-BE49-F238E27FC236}">
                  <a16:creationId xmlns:a16="http://schemas.microsoft.com/office/drawing/2014/main" id="{D61908A6-68F6-41EC-F86B-B160F8D83AA2}"/>
                </a:ext>
              </a:extLst>
            </p:cNvPr>
            <p:cNvGrpSpPr/>
            <p:nvPr/>
          </p:nvGrpSpPr>
          <p:grpSpPr>
            <a:xfrm>
              <a:off x="468257" y="10266697"/>
              <a:ext cx="87354" cy="1198335"/>
              <a:chOff x="498604" y="10832472"/>
              <a:chExt cx="87354" cy="1198335"/>
            </a:xfrm>
          </p:grpSpPr>
          <p:sp>
            <p:nvSpPr>
              <p:cNvPr id="71" name="Flowchart: Connector 70">
                <a:extLst>
                  <a:ext uri="{FF2B5EF4-FFF2-40B4-BE49-F238E27FC236}">
                    <a16:creationId xmlns:a16="http://schemas.microsoft.com/office/drawing/2014/main" id="{CBC45933-2F1C-99AC-48FB-A5D0A29C6D0C}"/>
                  </a:ext>
                </a:extLst>
              </p:cNvPr>
              <p:cNvSpPr/>
              <p:nvPr/>
            </p:nvSpPr>
            <p:spPr>
              <a:xfrm>
                <a:off x="498604" y="10832472"/>
                <a:ext cx="87354" cy="97374"/>
              </a:xfrm>
              <a:prstGeom prst="flowChartConnector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  <p:sp>
            <p:nvSpPr>
              <p:cNvPr id="72" name="Flowchart: Connector 71">
                <a:extLst>
                  <a:ext uri="{FF2B5EF4-FFF2-40B4-BE49-F238E27FC236}">
                    <a16:creationId xmlns:a16="http://schemas.microsoft.com/office/drawing/2014/main" id="{0AE12E07-5F7D-2449-9CE9-7408E34756F3}"/>
                  </a:ext>
                </a:extLst>
              </p:cNvPr>
              <p:cNvSpPr/>
              <p:nvPr/>
            </p:nvSpPr>
            <p:spPr>
              <a:xfrm>
                <a:off x="498604" y="11010501"/>
                <a:ext cx="87354" cy="97374"/>
              </a:xfrm>
              <a:prstGeom prst="flowChartConnector">
                <a:avLst/>
              </a:prstGeom>
              <a:solidFill>
                <a:srgbClr val="00B0F0"/>
              </a:solidFill>
              <a:ln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  <p:sp>
            <p:nvSpPr>
              <p:cNvPr id="73" name="Flowchart: Connector 72">
                <a:extLst>
                  <a:ext uri="{FF2B5EF4-FFF2-40B4-BE49-F238E27FC236}">
                    <a16:creationId xmlns:a16="http://schemas.microsoft.com/office/drawing/2014/main" id="{00758C09-D973-A742-CFFF-3F03CB65C863}"/>
                  </a:ext>
                </a:extLst>
              </p:cNvPr>
              <p:cNvSpPr/>
              <p:nvPr/>
            </p:nvSpPr>
            <p:spPr>
              <a:xfrm>
                <a:off x="498604" y="11202178"/>
                <a:ext cx="87354" cy="97374"/>
              </a:xfrm>
              <a:prstGeom prst="flowChartConnector">
                <a:avLst/>
              </a:prstGeom>
              <a:solidFill>
                <a:srgbClr val="FF99CC"/>
              </a:solidFill>
              <a:ln>
                <a:solidFill>
                  <a:srgbClr val="FF99CC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 dirty="0"/>
              </a:p>
            </p:txBody>
          </p:sp>
          <p:sp>
            <p:nvSpPr>
              <p:cNvPr id="74" name="Flowchart: Connector 73">
                <a:extLst>
                  <a:ext uri="{FF2B5EF4-FFF2-40B4-BE49-F238E27FC236}">
                    <a16:creationId xmlns:a16="http://schemas.microsoft.com/office/drawing/2014/main" id="{BCAD5BA7-5BED-AC8E-834B-ED5D6C6313B5}"/>
                  </a:ext>
                </a:extLst>
              </p:cNvPr>
              <p:cNvSpPr/>
              <p:nvPr/>
            </p:nvSpPr>
            <p:spPr>
              <a:xfrm>
                <a:off x="498604" y="11377668"/>
                <a:ext cx="87354" cy="97374"/>
              </a:xfrm>
              <a:prstGeom prst="flowChartConnector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  <p:sp>
            <p:nvSpPr>
              <p:cNvPr id="75" name="Flowchart: Connector 74">
                <a:extLst>
                  <a:ext uri="{FF2B5EF4-FFF2-40B4-BE49-F238E27FC236}">
                    <a16:creationId xmlns:a16="http://schemas.microsoft.com/office/drawing/2014/main" id="{0CA7D49D-D28B-D80C-44FA-F151551973A6}"/>
                  </a:ext>
                </a:extLst>
              </p:cNvPr>
              <p:cNvSpPr/>
              <p:nvPr/>
            </p:nvSpPr>
            <p:spPr>
              <a:xfrm>
                <a:off x="498604" y="11570034"/>
                <a:ext cx="87354" cy="97374"/>
              </a:xfrm>
              <a:prstGeom prst="flowChartConnector">
                <a:avLst/>
              </a:prstGeom>
              <a:solidFill>
                <a:srgbClr val="92D050"/>
              </a:solidFill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  <p:sp>
            <p:nvSpPr>
              <p:cNvPr id="76" name="Flowchart: Connector 75">
                <a:extLst>
                  <a:ext uri="{FF2B5EF4-FFF2-40B4-BE49-F238E27FC236}">
                    <a16:creationId xmlns:a16="http://schemas.microsoft.com/office/drawing/2014/main" id="{D19B785C-F4E8-F960-4273-689147F512F3}"/>
                  </a:ext>
                </a:extLst>
              </p:cNvPr>
              <p:cNvSpPr/>
              <p:nvPr/>
            </p:nvSpPr>
            <p:spPr>
              <a:xfrm>
                <a:off x="498604" y="11755935"/>
                <a:ext cx="87354" cy="97374"/>
              </a:xfrm>
              <a:prstGeom prst="flowChartConnector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>
                <a:solidFill>
                  <a:schemeClr val="accent5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  <p:sp>
            <p:nvSpPr>
              <p:cNvPr id="77" name="Flowchart: Connector 76">
                <a:extLst>
                  <a:ext uri="{FF2B5EF4-FFF2-40B4-BE49-F238E27FC236}">
                    <a16:creationId xmlns:a16="http://schemas.microsoft.com/office/drawing/2014/main" id="{3E8F5084-4F4B-561A-94C6-DF6F5B3D8E30}"/>
                  </a:ext>
                </a:extLst>
              </p:cNvPr>
              <p:cNvSpPr/>
              <p:nvPr/>
            </p:nvSpPr>
            <p:spPr>
              <a:xfrm>
                <a:off x="498604" y="11933433"/>
                <a:ext cx="87354" cy="97374"/>
              </a:xfrm>
              <a:prstGeom prst="flowChartConnector">
                <a:avLst/>
              </a:prstGeom>
              <a:solidFill>
                <a:srgbClr val="CC9900"/>
              </a:solidFill>
              <a:ln>
                <a:solidFill>
                  <a:srgbClr val="CC99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</p:grpSp>
      </p:grpSp>
      <p:sp>
        <p:nvSpPr>
          <p:cNvPr id="70" name="TextBox 69">
            <a:extLst>
              <a:ext uri="{FF2B5EF4-FFF2-40B4-BE49-F238E27FC236}">
                <a16:creationId xmlns:a16="http://schemas.microsoft.com/office/drawing/2014/main" id="{A0235149-3408-2988-504D-57283EA4FC23}"/>
              </a:ext>
            </a:extLst>
          </p:cNvPr>
          <p:cNvSpPr txBox="1"/>
          <p:nvPr/>
        </p:nvSpPr>
        <p:spPr>
          <a:xfrm>
            <a:off x="6165508" y="9662667"/>
            <a:ext cx="1270684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7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D11BBD54-19E6-A903-59E5-4F27B13B621B}"/>
              </a:ext>
            </a:extLst>
          </p:cNvPr>
          <p:cNvSpPr txBox="1"/>
          <p:nvPr/>
        </p:nvSpPr>
        <p:spPr>
          <a:xfrm>
            <a:off x="925436" y="124929"/>
            <a:ext cx="392615" cy="2674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38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9432C7E2-7866-128B-3A62-007AAB81C3EB}"/>
              </a:ext>
            </a:extLst>
          </p:cNvPr>
          <p:cNvSpPr txBox="1"/>
          <p:nvPr/>
        </p:nvSpPr>
        <p:spPr>
          <a:xfrm>
            <a:off x="925436" y="4250511"/>
            <a:ext cx="392615" cy="2674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38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526246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blue and yellow ribbon&#10;&#10;AI-generated content may be incorrect.">
            <a:extLst>
              <a:ext uri="{FF2B5EF4-FFF2-40B4-BE49-F238E27FC236}">
                <a16:creationId xmlns:a16="http://schemas.microsoft.com/office/drawing/2014/main" id="{31170B6B-DEE4-512E-E622-5B606D39220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34" t="25269" r="25361" b="25212"/>
          <a:stretch/>
        </p:blipFill>
        <p:spPr>
          <a:xfrm>
            <a:off x="1398933" y="1912161"/>
            <a:ext cx="1853330" cy="1038599"/>
          </a:xfrm>
          <a:prstGeom prst="rect">
            <a:avLst/>
          </a:prstGeom>
        </p:spPr>
      </p:pic>
      <p:pic>
        <p:nvPicPr>
          <p:cNvPr id="7" name="Picture 6" descr="A blue and yellow ribbon&#10;&#10;AI-generated content may be incorrect.">
            <a:extLst>
              <a:ext uri="{FF2B5EF4-FFF2-40B4-BE49-F238E27FC236}">
                <a16:creationId xmlns:a16="http://schemas.microsoft.com/office/drawing/2014/main" id="{99B647C9-BBC1-ADEA-088F-C6801248134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080" t="14755" r="22566" b="13407"/>
          <a:stretch/>
        </p:blipFill>
        <p:spPr>
          <a:xfrm>
            <a:off x="2325598" y="553114"/>
            <a:ext cx="1570690" cy="1189604"/>
          </a:xfrm>
          <a:prstGeom prst="rect">
            <a:avLst/>
          </a:prstGeom>
        </p:spPr>
      </p:pic>
      <p:pic>
        <p:nvPicPr>
          <p:cNvPr id="9" name="Picture 8" descr="A blue ribbon on a white background&#10;&#10;AI-generated content may be incorrect.">
            <a:extLst>
              <a:ext uri="{FF2B5EF4-FFF2-40B4-BE49-F238E27FC236}">
                <a16:creationId xmlns:a16="http://schemas.microsoft.com/office/drawing/2014/main" id="{FBA98618-853F-C1A4-BB56-E8A34E33D20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314" t="27923" r="34118" b="28504"/>
          <a:stretch/>
        </p:blipFill>
        <p:spPr>
          <a:xfrm>
            <a:off x="632447" y="534676"/>
            <a:ext cx="1532211" cy="1189604"/>
          </a:xfrm>
          <a:prstGeom prst="rect">
            <a:avLst/>
          </a:prstGeom>
        </p:spPr>
      </p:pic>
      <p:pic>
        <p:nvPicPr>
          <p:cNvPr id="11" name="Picture 10" descr="A green graph with white text&#10;&#10;AI-generated content may be incorrect.">
            <a:extLst>
              <a:ext uri="{FF2B5EF4-FFF2-40B4-BE49-F238E27FC236}">
                <a16:creationId xmlns:a16="http://schemas.microsoft.com/office/drawing/2014/main" id="{7F83B681-8F79-2280-015E-76B339E69BD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626"/>
          <a:stretch/>
        </p:blipFill>
        <p:spPr>
          <a:xfrm>
            <a:off x="4132068" y="248983"/>
            <a:ext cx="2078304" cy="270937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69191FB-C277-D035-1FF8-6E4DCE9892DD}"/>
              </a:ext>
            </a:extLst>
          </p:cNvPr>
          <p:cNvSpPr txBox="1"/>
          <p:nvPr/>
        </p:nvSpPr>
        <p:spPr>
          <a:xfrm>
            <a:off x="6165508" y="9662667"/>
            <a:ext cx="1270684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7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C704699-675A-FC18-7DF9-B3194BF0086A}"/>
              </a:ext>
            </a:extLst>
          </p:cNvPr>
          <p:cNvSpPr txBox="1"/>
          <p:nvPr/>
        </p:nvSpPr>
        <p:spPr>
          <a:xfrm>
            <a:off x="-16841" y="112964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51F0E64-8A1D-CD89-9E39-71974D9BD119}"/>
              </a:ext>
            </a:extLst>
          </p:cNvPr>
          <p:cNvSpPr txBox="1"/>
          <p:nvPr/>
        </p:nvSpPr>
        <p:spPr>
          <a:xfrm>
            <a:off x="3975615" y="127712"/>
            <a:ext cx="3209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18513751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4</TotalTime>
  <Words>28</Words>
  <Application>Microsoft Office PowerPoint</Application>
  <PresentationFormat>A4 Paper (210x297 mm)</PresentationFormat>
  <Paragraphs>14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Giulia LONGHI</dc:creator>
  <cp:lastModifiedBy>Giulia LONGHI</cp:lastModifiedBy>
  <cp:revision>1</cp:revision>
  <dcterms:created xsi:type="dcterms:W3CDTF">2025-05-13T05:03:39Z</dcterms:created>
  <dcterms:modified xsi:type="dcterms:W3CDTF">2025-05-19T14:00:52Z</dcterms:modified>
</cp:coreProperties>
</file>